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91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203948-CC7C-9E2C-5714-CFA4398460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037790-30A1-1CED-C30A-9053850CFD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CC0F88-E2D8-6EC5-67DE-260F3804E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B316A3-6AC4-BF5B-73CE-BED585130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42EEBB-E356-DE6A-6EF5-BD0F6BC9E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097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747F8-777A-980F-7AD3-10CDA0AEE5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A48B44-CD69-C367-6AD9-044BC9AB45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68FDCE-B759-0A27-A151-27E846DB1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6ED27-6C29-A9C3-1677-4DF35EBCF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5480DD-D223-45C7-D845-E965378A8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409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8708A7-2239-3E6B-2E12-6A700AC0B8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784FBE-D379-CC5C-B39D-84AF34990E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85F520-5134-CC72-95F0-1DCADC301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593285-6A7E-A995-49DE-EA4A60994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CE98A9-CC6A-19D8-CA4A-1D4CDA9A1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311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32BC1C-69DB-EB4A-B5D0-9641E50BE7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65DD7-8914-EE04-0B73-DF6DD1419B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DEBD2E-D437-5544-6AEE-5508FB1F6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34E795-8BE0-9FC9-307B-E60EA83B5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1A3E27-BAA2-6F7F-F837-24404755D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826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6F083-C9F5-A0CF-D52D-5DC4B1BAA5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5D74E2-284B-D1E8-07C8-E1F78E59AC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0C7FAD-9A8E-B2EB-00EC-11968E352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287672-AC8D-B0D0-1128-4C25A94FA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42E4E-FF5C-6888-03E6-435B838A8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723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CF1AE-33D3-0278-EB67-69F27A5B2C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74413D-5D70-57E9-A9F0-07F79A099D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711E76-A538-A085-88D2-CCEF235DAC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D7BB26-C199-5353-983E-2D0089F4D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E30753-E558-7F46-5CB5-7BFE45607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977997-91FF-DA1D-A2F7-DFB932474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832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71AFC-0FEE-A4C8-D747-F3A236A4A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3524E6-3FAD-576C-59B8-3EC832B82B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CEBC0D-147B-CBD6-56A9-7347E7B2C5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C64FC4-C6F0-0B1A-05C7-B653A50662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4C7FB6-A508-5DB9-33D2-E2A319B55B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E82DB3-C2AD-1899-A251-B0ECB089D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C6C4E6-11D2-CEE7-3C9D-1E6D82221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D2128D-2A0F-00AE-2A65-D23D11184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07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CE0F3C-85E0-2D2E-73E4-167B2549A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B5EF52-9B9F-2E52-48FC-AB2C8C289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510EDA-78C1-94A4-9CF1-4DF2E957D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AF3C75-A2C6-9C08-F762-5BEE3B5CD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693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CE54CE-5CD1-3EDB-4FE0-3D900083F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5F5F64-58AF-1BD2-D1F8-2DD66B2BDE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24B699-5749-B6E5-3A94-97CB7C34C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4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5D94E-32FF-15FB-291E-6EA007779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B836AE-B091-0C44-E613-A120A6409C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C3D09C-2441-26F9-23EB-5E40B5C3B6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B01E66-C22D-09E0-72BD-E8229CDBB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FBCABB-9427-2177-489E-9BA2D99BD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633D0A-9FB7-4EC7-B36D-247BBFEA57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611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A4415-83C3-5550-E814-33EA90DB18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3087AC5-C8D0-2CD6-78C2-9F793B08EA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8AACC0-5CA3-63CE-66B8-245ECFFC7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2CE893-B50B-B6AB-AAFA-7D2798A11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37B229-733A-E634-8D67-82557AA27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438EA3-FF7F-6202-95A9-49E8C19E1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386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FE0E97-F306-910A-664F-8CAA778F6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809707-DD83-5CD6-C72D-C5F35ED42E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D284C1-1381-D687-C240-0CD242C2AB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44A88B-3AFC-489C-B584-B97FA471BDD5}" type="datetimeFigureOut">
              <a:rPr lang="en-US" smtClean="0"/>
              <a:t>2025-01-1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8AFA69-B3DB-8B01-E6DE-06EA9DC20D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AF7B58-DC97-926A-8D29-0BD7E031A8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58A549-1418-4D1A-8AFE-D9B9DACFC7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29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>
            <a:extLst>
              <a:ext uri="{FF2B5EF4-FFF2-40B4-BE49-F238E27FC236}">
                <a16:creationId xmlns:a16="http://schemas.microsoft.com/office/drawing/2014/main" id="{EFBE06F9-D096-C6D8-A127-7751E2E19C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7321" y="1333631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7" name="image11.gif" descr="Imagen de la pantalla de un celular con letras  Descripción generada automáticamente con confianza baja">
            <a:extLst>
              <a:ext uri="{FF2B5EF4-FFF2-40B4-BE49-F238E27FC236}">
                <a16:creationId xmlns:a16="http://schemas.microsoft.com/office/drawing/2014/main" id="{956411E8-3DFD-B007-7B3D-4658FA8C6CCA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3428702" y="291180"/>
            <a:ext cx="4885916" cy="3944918"/>
          </a:xfrm>
          <a:prstGeom prst="rect">
            <a:avLst/>
          </a:prstGeom>
          <a:ln/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A7159BD-F54A-5C49-A810-936C569E1ABC}"/>
              </a:ext>
            </a:extLst>
          </p:cNvPr>
          <p:cNvSpPr txBox="1"/>
          <p:nvPr/>
        </p:nvSpPr>
        <p:spPr>
          <a:xfrm>
            <a:off x="1666559" y="4448539"/>
            <a:ext cx="9371556" cy="618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Palatino Linotype" panose="02040502050505030304" pitchFamily="18" charset="0"/>
              </a:rPr>
              <a:t>Video S1.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Palatino Linotype" panose="02040502050505030304" pitchFamily="18" charset="0"/>
              </a:rPr>
              <a:t> WGA-488-loaded PLGA NPs continuous time-course experiment during the first 60 min after addition of the NPs.</a:t>
            </a:r>
            <a:endParaRPr lang="en-US" sz="2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等线" panose="02010600030101010101" pitchFamily="2" charset="-122"/>
              <a:cs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6305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DPI</dc:creator>
  <cp:lastModifiedBy>MDPI</cp:lastModifiedBy>
  <cp:revision>1</cp:revision>
  <dcterms:created xsi:type="dcterms:W3CDTF">2025-01-10T14:06:04Z</dcterms:created>
  <dcterms:modified xsi:type="dcterms:W3CDTF">2025-01-10T14:07:09Z</dcterms:modified>
</cp:coreProperties>
</file>